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  <p:sldId id="259" r:id="rId4"/>
    <p:sldId id="260" r:id="rId5"/>
    <p:sldId id="263" r:id="rId6"/>
    <p:sldId id="262" r:id="rId7"/>
    <p:sldId id="264" r:id="rId8"/>
    <p:sldId id="265" r:id="rId9"/>
    <p:sldId id="266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399"/>
    <p:restoredTop sz="94694"/>
  </p:normalViewPr>
  <p:slideViewPr>
    <p:cSldViewPr snapToGrid="0" snapToObjects="1">
      <p:cViewPr varScale="1">
        <p:scale>
          <a:sx n="102" d="100"/>
          <a:sy n="102" d="100"/>
        </p:scale>
        <p:origin x="120" y="2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EB661B-9086-124D-B69F-B40925C4936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78BD81E-6139-5645-B566-97CDA78CE03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0F29A6-AE8B-9849-9A54-BEBB06C9B8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55BBE-791F-364B-A2F5-6CB519C44C28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D781FFB-2FC4-D949-8DD6-1B790AC729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50B873-C726-9243-85EE-452E89A3A6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4A59C8-40BA-344E-AE71-FB2E0E520A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78588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050844-6799-494F-8DE5-4BBB5F8490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18F7759-93EE-2944-ABD2-C3326B4F951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8593F3-8DC5-E748-A5A0-1DBE214284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55BBE-791F-364B-A2F5-6CB519C44C28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2611A0-8101-0F4D-8756-874459BC4D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D2F016-BF95-3942-89A4-F2FC13F1A6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4A59C8-40BA-344E-AE71-FB2E0E520A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83202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0332419-C4F5-7D42-BDE9-F1388419B34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4087E2D-A57A-2748-872A-7DD3DF09FAF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79797B-EA93-2745-A390-5C50F6C0AC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55BBE-791F-364B-A2F5-6CB519C44C28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786BA3-5B3F-B54B-9630-295025EB1E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7CFFC9-6E9E-8A48-B398-882AF0B2C8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4A59C8-40BA-344E-AE71-FB2E0E520A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43039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A07547-3CBD-3742-8FA6-0C469459B5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6F178FC-581F-0A4D-818F-F36687C5F44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774AC1-99D9-CD4D-A775-8CA8D6AE8A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55BBE-791F-364B-A2F5-6CB519C44C28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212A4A-2231-134E-98EF-82DF5DA6D3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2B2C26-ADB9-D94F-8E46-F28C032C3E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4A59C8-40BA-344E-AE71-FB2E0E520A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15339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45F407-1C4D-0B44-A2AC-9686813264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695B8C1-A77B-504A-A10A-B60ADF9579B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19CB58-D9A5-D240-A56D-91A1B47A3B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55BBE-791F-364B-A2F5-6CB519C44C28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0EF123-0F23-CC44-A3DB-E5AD06F81C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3E50FE-215B-9342-8489-018EFD6F2F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4A59C8-40BA-344E-AE71-FB2E0E520A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86928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8DB03B-6266-8D4D-9AAF-3275DB800A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A56301A-B069-3F4B-B88D-093F2671B64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B38F36A-692F-4441-8575-88EAC13A697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60DEB32-B626-6647-8AE0-ABC8F385E8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55BBE-791F-364B-A2F5-6CB519C44C28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39B8BDB-DE0C-084E-872A-8F6FC5E090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6E4E97A-2EE5-434E-AC79-9DEE015C8E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4A59C8-40BA-344E-AE71-FB2E0E520A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04236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2A79AA-6A8F-834D-891B-1CE991E69B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031B20A-D52F-7E4F-8EE8-8E83B725F2A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0A46D10-00FF-7F40-8E77-8AA03AA7AB0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8EA978E-E571-3344-B9F2-F82EF76FFEC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901D844-87F0-9A4A-9D81-9E521A31CB1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7A6D790-1B5A-0146-A501-670EDEF451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55BBE-791F-364B-A2F5-6CB519C44C28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394DE6B-6561-4340-8B86-1EAFEFC6D6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875673F-7A72-F54A-AF40-5B5D8EAB8B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4A59C8-40BA-344E-AE71-FB2E0E520A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3975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4EFA85-FD0A-E74C-93DC-0B09D71DBC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C367CFE-CD2B-C641-9803-0568B19D61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55BBE-791F-364B-A2F5-6CB519C44C28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C5D2593-1C7D-7646-A63E-D9CB8C4934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6CC1108-21C2-5A44-8899-1F1EACDBAD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4A59C8-40BA-344E-AE71-FB2E0E520A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13567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003BE44-4E6A-804D-93B2-A965CBF1E0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55BBE-791F-364B-A2F5-6CB519C44C28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48CB099-B301-7545-8D4F-4993FBB766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39C9194-DC75-4245-B509-ABFA4DA3A3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4A59C8-40BA-344E-AE71-FB2E0E520A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42803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71AE84-715B-9A4F-92F2-FEB43B7894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41F2E85-0D1D-2948-A93D-897E40D7719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FBFC546-2104-8E49-A50C-D32973C9380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90EB940-7037-AD4C-B842-071BD33293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55BBE-791F-364B-A2F5-6CB519C44C28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001245D-9C4D-C340-B72A-886F94D702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3CF5514-9381-FD41-8F31-B6ADE6C632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4A59C8-40BA-344E-AE71-FB2E0E520A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74696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63DAF2-3207-3D45-A592-41BB165748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FD8456E-6AF8-0E48-8734-9A7FF6C64DF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E40C9B6-0F18-C641-ACD7-1B5328A05E7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540436F-6FF5-864E-8FF2-2437496F7E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55BBE-791F-364B-A2F5-6CB519C44C28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67329F2-AA31-8D41-BE6D-1C2C819BD9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7111652-A057-FB42-93C9-FA12D858A9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4A59C8-40BA-344E-AE71-FB2E0E520A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03333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B244DFE-4568-2940-AF0C-A75667463F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E087639-7C1B-484D-9DC6-EAAE03EDFF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4C9933-829E-5D48-B23D-4FF7F243C74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855BBE-791F-364B-A2F5-6CB519C44C28}" type="datetimeFigureOut">
              <a:rPr lang="en-US" smtClean="0"/>
              <a:t>4/1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DFE880-B5EB-2D43-A75B-53E422C2436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CB914F-CEA6-8543-BEB7-20EE3789878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4A59C8-40BA-344E-AE71-FB2E0E520A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28742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f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TextBox 46">
            <a:extLst>
              <a:ext uri="{FF2B5EF4-FFF2-40B4-BE49-F238E27FC236}">
                <a16:creationId xmlns:a16="http://schemas.microsoft.com/office/drawing/2014/main" id="{C7BCDD7F-5289-4D8D-9133-E8B3AB8EF756}"/>
              </a:ext>
            </a:extLst>
          </p:cNvPr>
          <p:cNvSpPr txBox="1"/>
          <p:nvPr/>
        </p:nvSpPr>
        <p:spPr>
          <a:xfrm>
            <a:off x="130140" y="151937"/>
            <a:ext cx="3612336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Work Area: Floyd Lab – Drake</a:t>
            </a:r>
          </a:p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Image IDs: 375-378, 381-389</a:t>
            </a:r>
          </a:p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Cell Line: HeLa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13D5966E-706E-4DE0-B28E-BDDF043624AC}"/>
              </a:ext>
            </a:extLst>
          </p:cNvPr>
          <p:cNvSpPr txBox="1"/>
          <p:nvPr/>
        </p:nvSpPr>
        <p:spPr>
          <a:xfrm>
            <a:off x="4271641" y="666171"/>
            <a:ext cx="177548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RD4 Iso A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15E6024E-D15D-42C1-A4BF-DC3960DA217B}"/>
              </a:ext>
            </a:extLst>
          </p:cNvPr>
          <p:cNvSpPr txBox="1"/>
          <p:nvPr/>
        </p:nvSpPr>
        <p:spPr>
          <a:xfrm>
            <a:off x="4285889" y="1315383"/>
            <a:ext cx="181011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RD4 Iso C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FC7495C3-221C-4085-A2B9-BC9D4D821EDF}"/>
              </a:ext>
            </a:extLst>
          </p:cNvPr>
          <p:cNvSpPr txBox="1"/>
          <p:nvPr/>
        </p:nvSpPr>
        <p:spPr>
          <a:xfrm>
            <a:off x="4894230" y="4892554"/>
            <a:ext cx="114326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l-GR" sz="24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H2AX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9C2C9AB2-441D-434B-BE70-61E5C1CD2861}"/>
              </a:ext>
            </a:extLst>
          </p:cNvPr>
          <p:cNvSpPr txBox="1"/>
          <p:nvPr/>
        </p:nvSpPr>
        <p:spPr>
          <a:xfrm>
            <a:off x="4894230" y="5599761"/>
            <a:ext cx="11847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475EC141-2CC3-4EEF-A675-6A4555BEF687}"/>
              </a:ext>
            </a:extLst>
          </p:cNvPr>
          <p:cNvSpPr txBox="1"/>
          <p:nvPr/>
        </p:nvSpPr>
        <p:spPr>
          <a:xfrm>
            <a:off x="6976022" y="211511"/>
            <a:ext cx="97013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dBET6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584F448D-A87B-4A62-86F8-CF0F1611E5D2}"/>
              </a:ext>
            </a:extLst>
          </p:cNvPr>
          <p:cNvSpPr txBox="1"/>
          <p:nvPr/>
        </p:nvSpPr>
        <p:spPr>
          <a:xfrm>
            <a:off x="5088993" y="1907433"/>
            <a:ext cx="100700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RD2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3F80FEB5-E6BD-4605-8E0D-FD367779DA4D}"/>
              </a:ext>
            </a:extLst>
          </p:cNvPr>
          <p:cNvSpPr txBox="1"/>
          <p:nvPr/>
        </p:nvSpPr>
        <p:spPr>
          <a:xfrm>
            <a:off x="5088993" y="2526818"/>
            <a:ext cx="100700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RD3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20C5A597-A555-4A61-A027-0451BC079211}"/>
              </a:ext>
            </a:extLst>
          </p:cNvPr>
          <p:cNvSpPr txBox="1"/>
          <p:nvPr/>
        </p:nvSpPr>
        <p:spPr>
          <a:xfrm>
            <a:off x="6086366" y="216864"/>
            <a:ext cx="95410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pic>
        <p:nvPicPr>
          <p:cNvPr id="56" name="Picture 55">
            <a:extLst>
              <a:ext uri="{FF2B5EF4-FFF2-40B4-BE49-F238E27FC236}">
                <a16:creationId xmlns:a16="http://schemas.microsoft.com/office/drawing/2014/main" id="{270CDF8A-245C-473F-96AF-7B584AEDDB8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96000" y="626409"/>
            <a:ext cx="1775486" cy="541191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57" name="Picture 56">
            <a:extLst>
              <a:ext uri="{FF2B5EF4-FFF2-40B4-BE49-F238E27FC236}">
                <a16:creationId xmlns:a16="http://schemas.microsoft.com/office/drawing/2014/main" id="{B022B25D-2F97-419B-BA87-B645970E675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6712" y="1256132"/>
            <a:ext cx="1774774" cy="558907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58" name="Picture 57">
            <a:extLst>
              <a:ext uri="{FF2B5EF4-FFF2-40B4-BE49-F238E27FC236}">
                <a16:creationId xmlns:a16="http://schemas.microsoft.com/office/drawing/2014/main" id="{BF045CF2-E6FC-4B1D-B6F8-6410B419A1E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96000" y="1899602"/>
            <a:ext cx="1774774" cy="480535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59" name="Picture 58">
            <a:extLst>
              <a:ext uri="{FF2B5EF4-FFF2-40B4-BE49-F238E27FC236}">
                <a16:creationId xmlns:a16="http://schemas.microsoft.com/office/drawing/2014/main" id="{6C649332-5AA8-440B-B6A1-22EC49FC4FC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96000" y="2463092"/>
            <a:ext cx="1774774" cy="546084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60" name="Picture 59">
            <a:extLst>
              <a:ext uri="{FF2B5EF4-FFF2-40B4-BE49-F238E27FC236}">
                <a16:creationId xmlns:a16="http://schemas.microsoft.com/office/drawing/2014/main" id="{AF8B37F3-F473-4A74-86CF-34958A72200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096000" y="3099252"/>
            <a:ext cx="1774774" cy="556377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sp>
        <p:nvSpPr>
          <p:cNvPr id="61" name="TextBox 60">
            <a:extLst>
              <a:ext uri="{FF2B5EF4-FFF2-40B4-BE49-F238E27FC236}">
                <a16:creationId xmlns:a16="http://schemas.microsoft.com/office/drawing/2014/main" id="{6DB9ED73-64A2-4A62-A4F5-6BB1783C7CBC}"/>
              </a:ext>
            </a:extLst>
          </p:cNvPr>
          <p:cNvSpPr txBox="1"/>
          <p:nvPr/>
        </p:nvSpPr>
        <p:spPr>
          <a:xfrm>
            <a:off x="4252226" y="3157679"/>
            <a:ext cx="184377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RNAPII pS2</a:t>
            </a:r>
          </a:p>
        </p:txBody>
      </p:sp>
      <p:pic>
        <p:nvPicPr>
          <p:cNvPr id="62" name="Picture 61">
            <a:extLst>
              <a:ext uri="{FF2B5EF4-FFF2-40B4-BE49-F238E27FC236}">
                <a16:creationId xmlns:a16="http://schemas.microsoft.com/office/drawing/2014/main" id="{08F5B5F7-FCD8-42A0-8176-0285E43A587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086366" y="4421257"/>
            <a:ext cx="1774774" cy="295796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sp>
        <p:nvSpPr>
          <p:cNvPr id="63" name="TextBox 62">
            <a:extLst>
              <a:ext uri="{FF2B5EF4-FFF2-40B4-BE49-F238E27FC236}">
                <a16:creationId xmlns:a16="http://schemas.microsoft.com/office/drawing/2014/main" id="{ABAADA9F-1839-4858-94CF-600BDDA39C13}"/>
              </a:ext>
            </a:extLst>
          </p:cNvPr>
          <p:cNvSpPr txBox="1"/>
          <p:nvPr/>
        </p:nvSpPr>
        <p:spPr>
          <a:xfrm>
            <a:off x="4493990" y="4338322"/>
            <a:ext cx="158274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RPA pS33</a:t>
            </a:r>
          </a:p>
        </p:txBody>
      </p:sp>
      <p:pic>
        <p:nvPicPr>
          <p:cNvPr id="64" name="Picture 63">
            <a:extLst>
              <a:ext uri="{FF2B5EF4-FFF2-40B4-BE49-F238E27FC236}">
                <a16:creationId xmlns:a16="http://schemas.microsoft.com/office/drawing/2014/main" id="{C3C24336-51C0-40DB-A334-220EA5A670E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086366" y="5529721"/>
            <a:ext cx="1774774" cy="601747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65" name="Picture 64">
            <a:extLst>
              <a:ext uri="{FF2B5EF4-FFF2-40B4-BE49-F238E27FC236}">
                <a16:creationId xmlns:a16="http://schemas.microsoft.com/office/drawing/2014/main" id="{01927B61-2A68-4161-979F-48AEB8EDD0B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086366" y="4800701"/>
            <a:ext cx="1774774" cy="645372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66" name="Picture 65">
            <a:extLst>
              <a:ext uri="{FF2B5EF4-FFF2-40B4-BE49-F238E27FC236}">
                <a16:creationId xmlns:a16="http://schemas.microsoft.com/office/drawing/2014/main" id="{A35147BD-F3FE-4D34-AD95-DC7F34619458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096712" y="3755127"/>
            <a:ext cx="1764428" cy="572247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sp>
        <p:nvSpPr>
          <p:cNvPr id="67" name="TextBox 66">
            <a:extLst>
              <a:ext uri="{FF2B5EF4-FFF2-40B4-BE49-F238E27FC236}">
                <a16:creationId xmlns:a16="http://schemas.microsoft.com/office/drawing/2014/main" id="{389DC612-367F-49E6-8540-FE229BACCEFF}"/>
              </a:ext>
            </a:extLst>
          </p:cNvPr>
          <p:cNvSpPr txBox="1"/>
          <p:nvPr/>
        </p:nvSpPr>
        <p:spPr>
          <a:xfrm>
            <a:off x="4942614" y="3806927"/>
            <a:ext cx="115409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 err="1">
                <a:latin typeface="Arial" panose="020B0604020202020204" pitchFamily="34" charset="0"/>
                <a:cs typeface="Arial" panose="020B0604020202020204" pitchFamily="34" charset="0"/>
              </a:rPr>
              <a:t>cPARP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146225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>
            <a:extLst>
              <a:ext uri="{FF2B5EF4-FFF2-40B4-BE49-F238E27FC236}">
                <a16:creationId xmlns:a16="http://schemas.microsoft.com/office/drawing/2014/main" id="{ABFE344E-FC22-D948-A8BD-1EC49740399C}"/>
              </a:ext>
            </a:extLst>
          </p:cNvPr>
          <p:cNvSpPr txBox="1"/>
          <p:nvPr/>
        </p:nvSpPr>
        <p:spPr>
          <a:xfrm>
            <a:off x="130140" y="151937"/>
            <a:ext cx="2108269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BRD4 (green)</a:t>
            </a:r>
          </a:p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RNAPIIpS2 (red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C6D45AA-7A8B-AE47-966A-3ED134032C59}"/>
              </a:ext>
            </a:extLst>
          </p:cNvPr>
          <p:cNvSpPr txBox="1"/>
          <p:nvPr/>
        </p:nvSpPr>
        <p:spPr>
          <a:xfrm>
            <a:off x="2493369" y="2927479"/>
            <a:ext cx="177548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RD4 Iso 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1312590-3F01-8248-B0BC-1EC747C1BBF7}"/>
              </a:ext>
            </a:extLst>
          </p:cNvPr>
          <p:cNvSpPr txBox="1"/>
          <p:nvPr/>
        </p:nvSpPr>
        <p:spPr>
          <a:xfrm>
            <a:off x="2408986" y="4328369"/>
            <a:ext cx="181011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RD4 Iso C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7220DF9-3952-D04B-B70B-5AE90886DD1B}"/>
              </a:ext>
            </a:extLst>
          </p:cNvPr>
          <p:cNvSpPr txBox="1"/>
          <p:nvPr/>
        </p:nvSpPr>
        <p:spPr>
          <a:xfrm>
            <a:off x="5158511" y="1272983"/>
            <a:ext cx="97013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dBET6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514EA148-0F57-4544-B758-37089E4D397A}"/>
              </a:ext>
            </a:extLst>
          </p:cNvPr>
          <p:cNvSpPr txBox="1"/>
          <p:nvPr/>
        </p:nvSpPr>
        <p:spPr>
          <a:xfrm>
            <a:off x="8272916" y="3333850"/>
            <a:ext cx="6992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160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BBA4427-CAF7-C145-AA61-4C01C278A89D}"/>
              </a:ext>
            </a:extLst>
          </p:cNvPr>
          <p:cNvSpPr txBox="1"/>
          <p:nvPr/>
        </p:nvSpPr>
        <p:spPr>
          <a:xfrm>
            <a:off x="8261754" y="3888695"/>
            <a:ext cx="6992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125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2B28DCF-09E7-6640-81A1-BDA6AEEDD146}"/>
              </a:ext>
            </a:extLst>
          </p:cNvPr>
          <p:cNvSpPr txBox="1"/>
          <p:nvPr/>
        </p:nvSpPr>
        <p:spPr>
          <a:xfrm>
            <a:off x="4268855" y="1278336"/>
            <a:ext cx="95410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5B19E1DD-B9BF-3D4A-AD76-A2AF072BDD20}"/>
              </a:ext>
            </a:extLst>
          </p:cNvPr>
          <p:cNvSpPr txBox="1"/>
          <p:nvPr/>
        </p:nvSpPr>
        <p:spPr>
          <a:xfrm>
            <a:off x="2459225" y="2486132"/>
            <a:ext cx="184377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RNAPII pS2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DA7832F-7C70-E345-A987-30F4D1674B42}"/>
              </a:ext>
            </a:extLst>
          </p:cNvPr>
          <p:cNvSpPr txBox="1"/>
          <p:nvPr/>
        </p:nvSpPr>
        <p:spPr>
          <a:xfrm>
            <a:off x="8272916" y="4647885"/>
            <a:ext cx="52771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90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E4C8AEF7-8AAB-A24F-8E35-E52DDDFB3F0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85687" y="1773749"/>
            <a:ext cx="3987229" cy="40949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985129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>
            <a:extLst>
              <a:ext uri="{FF2B5EF4-FFF2-40B4-BE49-F238E27FC236}">
                <a16:creationId xmlns:a16="http://schemas.microsoft.com/office/drawing/2014/main" id="{ABFE344E-FC22-D948-A8BD-1EC49740399C}"/>
              </a:ext>
            </a:extLst>
          </p:cNvPr>
          <p:cNvSpPr txBox="1"/>
          <p:nvPr/>
        </p:nvSpPr>
        <p:spPr>
          <a:xfrm>
            <a:off x="130140" y="151937"/>
            <a:ext cx="87075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BRD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C6D45AA-7A8B-AE47-966A-3ED134032C59}"/>
              </a:ext>
            </a:extLst>
          </p:cNvPr>
          <p:cNvSpPr txBox="1"/>
          <p:nvPr/>
        </p:nvSpPr>
        <p:spPr>
          <a:xfrm>
            <a:off x="3460444" y="3326101"/>
            <a:ext cx="100700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RD2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7220DF9-3952-D04B-B70B-5AE90886DD1B}"/>
              </a:ext>
            </a:extLst>
          </p:cNvPr>
          <p:cNvSpPr txBox="1"/>
          <p:nvPr/>
        </p:nvSpPr>
        <p:spPr>
          <a:xfrm>
            <a:off x="5158511" y="1272983"/>
            <a:ext cx="97013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dBET6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514EA148-0F57-4544-B758-37089E4D397A}"/>
              </a:ext>
            </a:extLst>
          </p:cNvPr>
          <p:cNvSpPr txBox="1"/>
          <p:nvPr/>
        </p:nvSpPr>
        <p:spPr>
          <a:xfrm>
            <a:off x="6046385" y="2743646"/>
            <a:ext cx="6992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160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BBA4427-CAF7-C145-AA61-4C01C278A89D}"/>
              </a:ext>
            </a:extLst>
          </p:cNvPr>
          <p:cNvSpPr txBox="1"/>
          <p:nvPr/>
        </p:nvSpPr>
        <p:spPr>
          <a:xfrm>
            <a:off x="6045507" y="3095268"/>
            <a:ext cx="6992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125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2B28DCF-09E7-6640-81A1-BDA6AEEDD146}"/>
              </a:ext>
            </a:extLst>
          </p:cNvPr>
          <p:cNvSpPr txBox="1"/>
          <p:nvPr/>
        </p:nvSpPr>
        <p:spPr>
          <a:xfrm>
            <a:off x="4268855" y="1278336"/>
            <a:ext cx="95410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DA7832F-7C70-E345-A987-30F4D1674B42}"/>
              </a:ext>
            </a:extLst>
          </p:cNvPr>
          <p:cNvSpPr txBox="1"/>
          <p:nvPr/>
        </p:nvSpPr>
        <p:spPr>
          <a:xfrm>
            <a:off x="6145184" y="3556933"/>
            <a:ext cx="52771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90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9F0C9DE2-A91A-9341-90A0-8ED7A9C2978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624547" y="1784297"/>
            <a:ext cx="1423908" cy="4389120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006D70E8-1632-E348-92DF-0C0D7521161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522"/>
          <a:stretch/>
        </p:blipFill>
        <p:spPr>
          <a:xfrm>
            <a:off x="4467451" y="1784297"/>
            <a:ext cx="1578934" cy="4521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7635373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>
            <a:extLst>
              <a:ext uri="{FF2B5EF4-FFF2-40B4-BE49-F238E27FC236}">
                <a16:creationId xmlns:a16="http://schemas.microsoft.com/office/drawing/2014/main" id="{ABFE344E-FC22-D948-A8BD-1EC49740399C}"/>
              </a:ext>
            </a:extLst>
          </p:cNvPr>
          <p:cNvSpPr txBox="1"/>
          <p:nvPr/>
        </p:nvSpPr>
        <p:spPr>
          <a:xfrm>
            <a:off x="130140" y="151937"/>
            <a:ext cx="87075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BRD3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C6D45AA-7A8B-AE47-966A-3ED134032C59}"/>
              </a:ext>
            </a:extLst>
          </p:cNvPr>
          <p:cNvSpPr txBox="1"/>
          <p:nvPr/>
        </p:nvSpPr>
        <p:spPr>
          <a:xfrm>
            <a:off x="3444168" y="3035155"/>
            <a:ext cx="100700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RD3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7220DF9-3952-D04B-B70B-5AE90886DD1B}"/>
              </a:ext>
            </a:extLst>
          </p:cNvPr>
          <p:cNvSpPr txBox="1"/>
          <p:nvPr/>
        </p:nvSpPr>
        <p:spPr>
          <a:xfrm>
            <a:off x="5158511" y="1272983"/>
            <a:ext cx="97013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dBET6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514EA148-0F57-4544-B758-37089E4D397A}"/>
              </a:ext>
            </a:extLst>
          </p:cNvPr>
          <p:cNvSpPr txBox="1"/>
          <p:nvPr/>
        </p:nvSpPr>
        <p:spPr>
          <a:xfrm>
            <a:off x="6096000" y="2352948"/>
            <a:ext cx="6992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160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BBA4427-CAF7-C145-AA61-4C01C278A89D}"/>
              </a:ext>
            </a:extLst>
          </p:cNvPr>
          <p:cNvSpPr txBox="1"/>
          <p:nvPr/>
        </p:nvSpPr>
        <p:spPr>
          <a:xfrm>
            <a:off x="6095122" y="2704570"/>
            <a:ext cx="6992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125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2B28DCF-09E7-6640-81A1-BDA6AEEDD146}"/>
              </a:ext>
            </a:extLst>
          </p:cNvPr>
          <p:cNvSpPr txBox="1"/>
          <p:nvPr/>
        </p:nvSpPr>
        <p:spPr>
          <a:xfrm>
            <a:off x="4268855" y="1278336"/>
            <a:ext cx="95410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DA7832F-7C70-E345-A987-30F4D1674B42}"/>
              </a:ext>
            </a:extLst>
          </p:cNvPr>
          <p:cNvSpPr txBox="1"/>
          <p:nvPr/>
        </p:nvSpPr>
        <p:spPr>
          <a:xfrm>
            <a:off x="6194799" y="3166235"/>
            <a:ext cx="52771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90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9F0C9DE2-A91A-9341-90A0-8ED7A9C2978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624547" y="1784297"/>
            <a:ext cx="1423908" cy="438912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8184952B-1065-F940-A81C-AA8AADB5404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017"/>
          <a:stretch/>
        </p:blipFill>
        <p:spPr>
          <a:xfrm>
            <a:off x="4467450" y="1784297"/>
            <a:ext cx="1676855" cy="462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278793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B163DB6E-BC73-364B-8B91-D67544FB084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29831" y="2665613"/>
            <a:ext cx="3355653" cy="1278344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ABFE344E-FC22-D948-A8BD-1EC49740399C}"/>
              </a:ext>
            </a:extLst>
          </p:cNvPr>
          <p:cNvSpPr txBox="1"/>
          <p:nvPr/>
        </p:nvSpPr>
        <p:spPr>
          <a:xfrm>
            <a:off x="612278" y="176875"/>
            <a:ext cx="101835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C6D45AA-7A8B-AE47-966A-3ED134032C59}"/>
              </a:ext>
            </a:extLst>
          </p:cNvPr>
          <p:cNvSpPr txBox="1"/>
          <p:nvPr/>
        </p:nvSpPr>
        <p:spPr>
          <a:xfrm>
            <a:off x="2645083" y="3198167"/>
            <a:ext cx="11847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7220DF9-3952-D04B-B70B-5AE90886DD1B}"/>
              </a:ext>
            </a:extLst>
          </p:cNvPr>
          <p:cNvSpPr txBox="1"/>
          <p:nvPr/>
        </p:nvSpPr>
        <p:spPr>
          <a:xfrm>
            <a:off x="4884192" y="2159137"/>
            <a:ext cx="97013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dBET6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BBA4427-CAF7-C145-AA61-4C01C278A89D}"/>
              </a:ext>
            </a:extLst>
          </p:cNvPr>
          <p:cNvSpPr txBox="1"/>
          <p:nvPr/>
        </p:nvSpPr>
        <p:spPr>
          <a:xfrm>
            <a:off x="6612728" y="3109975"/>
            <a:ext cx="52771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2B28DCF-09E7-6640-81A1-BDA6AEEDD146}"/>
              </a:ext>
            </a:extLst>
          </p:cNvPr>
          <p:cNvSpPr txBox="1"/>
          <p:nvPr/>
        </p:nvSpPr>
        <p:spPr>
          <a:xfrm>
            <a:off x="3994536" y="2164490"/>
            <a:ext cx="95410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9F0C9DE2-A91A-9341-90A0-8ED7A9C2978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624547" y="1784297"/>
            <a:ext cx="1423908" cy="43891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025116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>
            <a:extLst>
              <a:ext uri="{FF2B5EF4-FFF2-40B4-BE49-F238E27FC236}">
                <a16:creationId xmlns:a16="http://schemas.microsoft.com/office/drawing/2014/main" id="{ABFE344E-FC22-D948-A8BD-1EC49740399C}"/>
              </a:ext>
            </a:extLst>
          </p:cNvPr>
          <p:cNvSpPr txBox="1"/>
          <p:nvPr/>
        </p:nvSpPr>
        <p:spPr>
          <a:xfrm>
            <a:off x="123298" y="176875"/>
            <a:ext cx="15073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RPA2 pS33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C6D45AA-7A8B-AE47-966A-3ED134032C59}"/>
              </a:ext>
            </a:extLst>
          </p:cNvPr>
          <p:cNvSpPr txBox="1"/>
          <p:nvPr/>
        </p:nvSpPr>
        <p:spPr>
          <a:xfrm>
            <a:off x="1243395" y="3304785"/>
            <a:ext cx="177125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RPA2 pS33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7220DF9-3952-D04B-B70B-5AE90886DD1B}"/>
              </a:ext>
            </a:extLst>
          </p:cNvPr>
          <p:cNvSpPr txBox="1"/>
          <p:nvPr/>
        </p:nvSpPr>
        <p:spPr>
          <a:xfrm>
            <a:off x="4884192" y="2159137"/>
            <a:ext cx="97013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dBET6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BBA4427-CAF7-C145-AA61-4C01C278A89D}"/>
              </a:ext>
            </a:extLst>
          </p:cNvPr>
          <p:cNvSpPr txBox="1"/>
          <p:nvPr/>
        </p:nvSpPr>
        <p:spPr>
          <a:xfrm>
            <a:off x="6220157" y="2773909"/>
            <a:ext cx="52771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2B28DCF-09E7-6640-81A1-BDA6AEEDD146}"/>
              </a:ext>
            </a:extLst>
          </p:cNvPr>
          <p:cNvSpPr txBox="1"/>
          <p:nvPr/>
        </p:nvSpPr>
        <p:spPr>
          <a:xfrm>
            <a:off x="3994536" y="2164490"/>
            <a:ext cx="95410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DA7832F-7C70-E345-A987-30F4D1674B42}"/>
              </a:ext>
            </a:extLst>
          </p:cNvPr>
          <p:cNvSpPr txBox="1"/>
          <p:nvPr/>
        </p:nvSpPr>
        <p:spPr>
          <a:xfrm>
            <a:off x="6220157" y="3517192"/>
            <a:ext cx="52771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9F0C9DE2-A91A-9341-90A0-8ED7A9C2978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624547" y="1784297"/>
            <a:ext cx="1423908" cy="438912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F55C487C-8F28-D44A-8B4E-28B132A6062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54356" y="2754088"/>
            <a:ext cx="3183313" cy="10352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3733802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>
            <a:extLst>
              <a:ext uri="{FF2B5EF4-FFF2-40B4-BE49-F238E27FC236}">
                <a16:creationId xmlns:a16="http://schemas.microsoft.com/office/drawing/2014/main" id="{ABFE344E-FC22-D948-A8BD-1EC49740399C}"/>
              </a:ext>
            </a:extLst>
          </p:cNvPr>
          <p:cNvSpPr txBox="1"/>
          <p:nvPr/>
        </p:nvSpPr>
        <p:spPr>
          <a:xfrm>
            <a:off x="646070" y="176875"/>
            <a:ext cx="98456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l-GR" sz="20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H2AX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C6D45AA-7A8B-AE47-966A-3ED134032C59}"/>
              </a:ext>
            </a:extLst>
          </p:cNvPr>
          <p:cNvSpPr txBox="1"/>
          <p:nvPr/>
        </p:nvSpPr>
        <p:spPr>
          <a:xfrm>
            <a:off x="2656216" y="3835144"/>
            <a:ext cx="114326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l-GR" sz="24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H2AX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7220DF9-3952-D04B-B70B-5AE90886DD1B}"/>
              </a:ext>
            </a:extLst>
          </p:cNvPr>
          <p:cNvSpPr txBox="1"/>
          <p:nvPr/>
        </p:nvSpPr>
        <p:spPr>
          <a:xfrm>
            <a:off x="4626497" y="1979544"/>
            <a:ext cx="97013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dBET6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2B28DCF-09E7-6640-81A1-BDA6AEEDD146}"/>
              </a:ext>
            </a:extLst>
          </p:cNvPr>
          <p:cNvSpPr txBox="1"/>
          <p:nvPr/>
        </p:nvSpPr>
        <p:spPr>
          <a:xfrm>
            <a:off x="3736841" y="1984897"/>
            <a:ext cx="95410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DA7832F-7C70-E345-A987-30F4D1674B42}"/>
              </a:ext>
            </a:extLst>
          </p:cNvPr>
          <p:cNvSpPr txBox="1"/>
          <p:nvPr/>
        </p:nvSpPr>
        <p:spPr>
          <a:xfrm>
            <a:off x="5491806" y="3835144"/>
            <a:ext cx="52771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9F0C9DE2-A91A-9341-90A0-8ED7A9C2978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624547" y="1784297"/>
            <a:ext cx="1423908" cy="4389120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5BFB1E09-D659-E746-B36C-8A74FD96DBC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04306" y="2385007"/>
            <a:ext cx="1587500" cy="3187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1289402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>
            <a:extLst>
              <a:ext uri="{FF2B5EF4-FFF2-40B4-BE49-F238E27FC236}">
                <a16:creationId xmlns:a16="http://schemas.microsoft.com/office/drawing/2014/main" id="{ABFE344E-FC22-D948-A8BD-1EC49740399C}"/>
              </a:ext>
            </a:extLst>
          </p:cNvPr>
          <p:cNvSpPr txBox="1"/>
          <p:nvPr/>
        </p:nvSpPr>
        <p:spPr>
          <a:xfrm>
            <a:off x="646070" y="176875"/>
            <a:ext cx="98456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l-GR" sz="20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H2AX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C6D45AA-7A8B-AE47-966A-3ED134032C59}"/>
              </a:ext>
            </a:extLst>
          </p:cNvPr>
          <p:cNvSpPr txBox="1"/>
          <p:nvPr/>
        </p:nvSpPr>
        <p:spPr>
          <a:xfrm>
            <a:off x="2656216" y="3835144"/>
            <a:ext cx="114326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l-GR" sz="24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H2AX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7220DF9-3952-D04B-B70B-5AE90886DD1B}"/>
              </a:ext>
            </a:extLst>
          </p:cNvPr>
          <p:cNvSpPr txBox="1"/>
          <p:nvPr/>
        </p:nvSpPr>
        <p:spPr>
          <a:xfrm>
            <a:off x="4626497" y="1979544"/>
            <a:ext cx="97013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dBET6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2B28DCF-09E7-6640-81A1-BDA6AEEDD146}"/>
              </a:ext>
            </a:extLst>
          </p:cNvPr>
          <p:cNvSpPr txBox="1"/>
          <p:nvPr/>
        </p:nvSpPr>
        <p:spPr>
          <a:xfrm>
            <a:off x="3736841" y="1984897"/>
            <a:ext cx="95410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DA7832F-7C70-E345-A987-30F4D1674B42}"/>
              </a:ext>
            </a:extLst>
          </p:cNvPr>
          <p:cNvSpPr txBox="1"/>
          <p:nvPr/>
        </p:nvSpPr>
        <p:spPr>
          <a:xfrm>
            <a:off x="5491806" y="3835144"/>
            <a:ext cx="52771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9F0C9DE2-A91A-9341-90A0-8ED7A9C2978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624547" y="1784297"/>
            <a:ext cx="1423908" cy="4389120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5BFB1E09-D659-E746-B36C-8A74FD96DBC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04306" y="2385007"/>
            <a:ext cx="1587500" cy="3187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1101386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>
            <a:extLst>
              <a:ext uri="{FF2B5EF4-FFF2-40B4-BE49-F238E27FC236}">
                <a16:creationId xmlns:a16="http://schemas.microsoft.com/office/drawing/2014/main" id="{ABFE344E-FC22-D948-A8BD-1EC49740399C}"/>
              </a:ext>
            </a:extLst>
          </p:cNvPr>
          <p:cNvSpPr txBox="1"/>
          <p:nvPr/>
        </p:nvSpPr>
        <p:spPr>
          <a:xfrm>
            <a:off x="636258" y="176875"/>
            <a:ext cx="99437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000" dirty="0" err="1">
                <a:latin typeface="Arial" panose="020B0604020202020204" pitchFamily="34" charset="0"/>
                <a:cs typeface="Arial" panose="020B0604020202020204" pitchFamily="34" charset="0"/>
              </a:rPr>
              <a:t>cPARP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C6D45AA-7A8B-AE47-966A-3ED134032C59}"/>
              </a:ext>
            </a:extLst>
          </p:cNvPr>
          <p:cNvSpPr txBox="1"/>
          <p:nvPr/>
        </p:nvSpPr>
        <p:spPr>
          <a:xfrm>
            <a:off x="2739648" y="2817049"/>
            <a:ext cx="115409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 err="1">
                <a:latin typeface="Arial" panose="020B0604020202020204" pitchFamily="34" charset="0"/>
                <a:cs typeface="Arial" panose="020B0604020202020204" pitchFamily="34" charset="0"/>
              </a:rPr>
              <a:t>cPARP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7220DF9-3952-D04B-B70B-5AE90886DD1B}"/>
              </a:ext>
            </a:extLst>
          </p:cNvPr>
          <p:cNvSpPr txBox="1"/>
          <p:nvPr/>
        </p:nvSpPr>
        <p:spPr>
          <a:xfrm>
            <a:off x="5295799" y="841878"/>
            <a:ext cx="97013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dBET6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2B28DCF-09E7-6640-81A1-BDA6AEEDD146}"/>
              </a:ext>
            </a:extLst>
          </p:cNvPr>
          <p:cNvSpPr txBox="1"/>
          <p:nvPr/>
        </p:nvSpPr>
        <p:spPr>
          <a:xfrm>
            <a:off x="4406143" y="847231"/>
            <a:ext cx="95410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9F0C9DE2-A91A-9341-90A0-8ED7A9C2978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624547" y="1784297"/>
            <a:ext cx="1423908" cy="438912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5551D478-8423-40A1-B379-091F5DAB816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84650" y="1241988"/>
            <a:ext cx="2809875" cy="53054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371953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7</TotalTime>
  <Words>101</Words>
  <Application>Microsoft Office PowerPoint</Application>
  <PresentationFormat>Widescreen</PresentationFormat>
  <Paragraphs>63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3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ake Edwards</dc:creator>
  <cp:lastModifiedBy>Drake Edwards</cp:lastModifiedBy>
  <cp:revision>7</cp:revision>
  <dcterms:created xsi:type="dcterms:W3CDTF">2019-11-15T19:10:41Z</dcterms:created>
  <dcterms:modified xsi:type="dcterms:W3CDTF">2020-04-13T02:56:43Z</dcterms:modified>
</cp:coreProperties>
</file>